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309"/>
    <p:restoredTop sz="94626"/>
  </p:normalViewPr>
  <p:slideViewPr>
    <p:cSldViewPr snapToGrid="0">
      <p:cViewPr varScale="1">
        <p:scale>
          <a:sx n="72" d="100"/>
          <a:sy n="72" d="100"/>
        </p:scale>
        <p:origin x="232" y="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167F85-F124-9A24-BF68-54753607E0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DC0C29-B354-CACC-3E80-7F6AC769F8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7B9297-F2D9-BFCA-BD5D-92371FC61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B158E7-BB0E-DFC0-CF9D-4F1608E0E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58D041-3767-8BC9-6E66-AE6DFE7D7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080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1170A8-21EB-899F-E114-0E2B12D7A5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A8E00D-076F-B1AD-53E5-42B0F31DAA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BDA661-3108-D72C-0E12-F99553013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E3BB6A-4760-A698-34C1-ED6563E40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87A404-E417-D8F2-D2D6-50D223D58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55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11F487-2FD5-96F1-20DC-3280E5EFEF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EE1552-E6D7-CE25-50BE-9CEA8438B1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324DAE-974A-E87C-2F40-37EEDA0E8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EB980-1D77-B247-2757-31D21CA1A3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DC3511-25E7-DC44-C088-585DBD1708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14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395AFD-5CF4-7A73-8702-7FF13460A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C3990F-A275-79FA-9CB2-37C8D768B4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D20B7F-B175-DD6C-F267-AB183C30D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20ACE2-D25E-C2C9-2317-63B9BDBB2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D7440C-FF80-6F2E-87D7-0C10715A3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846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05A9C2-A85A-ECC6-7F34-D73D72E345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57254B-40F3-CE51-F9CB-04B565477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769C31-2612-07FD-FB24-527EE7371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558DE5-D1B1-ACE0-8346-4B4F732A7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BEAEB1-236E-4052-5497-3BD744580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722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E3EAF0-428E-4A2C-CA21-BE06905038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CB50ED-D35B-5F4D-ECB4-74858AE3D7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0AE193-F47B-3C55-643E-EC8C3C5D86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E1D3EA-F261-52C9-64C2-C0F5E34A3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DC849D-D637-B45B-B651-27D93AE51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DCB697-8C6A-BD28-43D0-CB51C3AF6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710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1F0B31-8E44-E007-DC8F-8EFCE2C44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61043B-3B71-3C8A-3F74-EAE42FA31F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2A1380-B3CA-8DE3-DB54-55DF10717B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DDAE202-BE36-61DB-B88E-0A7CA682D3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FD5526-D202-F64E-DA5C-8BE5D6E096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38DF74B-DEC5-5530-038A-25FED5521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AA3367-F5F5-B9B1-9D7C-40FD42AC1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D1E8DE-7918-00AA-FE83-97AF7F394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500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9F6FC-696C-3BAF-F82C-086A49E87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5E2B82-0BDB-DA68-05E5-3824751BE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BDE16F0-EDCF-63CF-D839-0DB15100F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E7F0C36-49E2-1117-2EB2-15B70F4BBE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36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0ADBFF-F530-A89D-AE04-59865DFA5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6F9B52-1679-755A-1AC8-FC93C7ABA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5F3789-195C-3793-4744-D35B97FFD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73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0560B5-9F8D-B8E9-4F21-643737F37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A44184-BE62-92A4-DE1B-0D8568CD97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246BB8-134C-D77A-AD8B-C46C696BBE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73C4B9-9C79-2D42-2210-4A2A4D61B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C9C888-9F38-9626-BFD6-BCBA2F81B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FBF762-3CCF-6FF4-9291-862C694FA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377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60119-3646-E5F7-9026-FD4CD23EF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06A270-6334-9A32-0768-8D4411ADA7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CDBEC-3DBC-9C6E-C909-75538EEDB9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27698B-438E-93B6-7746-6B7090C6A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5B510B-D74E-0E99-A407-65D906048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B8AEFC-7D00-7D57-3DCB-7CBFA71A9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58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8997D3-6EF2-FF75-1CDA-5D25638AC0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271A6F-20C9-89F1-2CD6-91B02C8479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B7C84-9404-CA44-3A3A-28869FBBA5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C1729-7C00-8146-9A27-4F27A9EF2CEF}" type="datetimeFigureOut">
              <a:rPr lang="en-US" smtClean="0"/>
              <a:t>7/2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2A477-43A7-4804-8B41-57A83A8199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031F0A-CDE2-642B-2034-E218A56243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9E282-F536-764A-9E01-ECC862599C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917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840116C-2D10-907D-23C1-8B7B33BB10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8400" y="1246097"/>
            <a:ext cx="7315200" cy="5486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DF62624-8C77-96FA-8171-BCEF61E7FCAC}"/>
              </a:ext>
            </a:extLst>
          </p:cNvPr>
          <p:cNvSpPr txBox="1"/>
          <p:nvPr/>
        </p:nvSpPr>
        <p:spPr>
          <a:xfrm>
            <a:off x="448236" y="29540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2: Waterfall plot for overall response rate in response evaluable patients.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1253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ron Scott</dc:creator>
  <cp:lastModifiedBy>Aaron Scott</cp:lastModifiedBy>
  <cp:revision>1</cp:revision>
  <dcterms:created xsi:type="dcterms:W3CDTF">2022-07-21T20:34:51Z</dcterms:created>
  <dcterms:modified xsi:type="dcterms:W3CDTF">2022-07-21T20:35:45Z</dcterms:modified>
</cp:coreProperties>
</file>